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2" d="100"/>
          <a:sy n="42" d="100"/>
        </p:scale>
        <p:origin x="2316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uis Irwin" userId="4c33d026aeddbf47" providerId="LiveId" clId="{B961C20A-3A18-424D-9B11-F251A5C0D324}"/>
    <pc:docChg chg="modSld">
      <pc:chgData name="Louis Irwin" userId="4c33d026aeddbf47" providerId="LiveId" clId="{B961C20A-3A18-424D-9B11-F251A5C0D324}" dt="2024-02-03T19:26:06.541" v="15" actId="255"/>
      <pc:docMkLst>
        <pc:docMk/>
      </pc:docMkLst>
      <pc:sldChg chg="modSp mod">
        <pc:chgData name="Louis Irwin" userId="4c33d026aeddbf47" providerId="LiveId" clId="{B961C20A-3A18-424D-9B11-F251A5C0D324}" dt="2024-02-03T19:26:06.541" v="15" actId="255"/>
        <pc:sldMkLst>
          <pc:docMk/>
          <pc:sldMk cId="2894342001" sldId="257"/>
        </pc:sldMkLst>
        <pc:spChg chg="mod">
          <ac:chgData name="Louis Irwin" userId="4c33d026aeddbf47" providerId="LiveId" clId="{B961C20A-3A18-424D-9B11-F251A5C0D324}" dt="2024-02-03T18:48:01.123" v="14" actId="20577"/>
          <ac:spMkLst>
            <pc:docMk/>
            <pc:sldMk cId="2894342001" sldId="257"/>
            <ac:spMk id="3" creationId="{D8183EEB-A81F-4E09-88D9-61DFC80CB6B0}"/>
          </ac:spMkLst>
        </pc:spChg>
        <pc:spChg chg="mod">
          <ac:chgData name="Louis Irwin" userId="4c33d026aeddbf47" providerId="LiveId" clId="{B961C20A-3A18-424D-9B11-F251A5C0D324}" dt="2024-02-03T19:26:06.541" v="15" actId="255"/>
          <ac:spMkLst>
            <pc:docMk/>
            <pc:sldMk cId="2894342001" sldId="257"/>
            <ac:spMk id="5" creationId="{F8DA748F-2B64-440A-9920-DC237148EAF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532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507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871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036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166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00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750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187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098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646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604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F74EF9-F734-439F-AB5C-E8E301AC2DA6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9D23C4-8564-4E79-997E-77115FBCD5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257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D8183EEB-A81F-4E09-88D9-61DFC80CB6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23900" y="8412267"/>
            <a:ext cx="6076950" cy="2428451"/>
          </a:xfrm>
        </p:spPr>
        <p:txBody>
          <a:bodyPr/>
          <a:lstStyle/>
          <a:p>
            <a:pPr algn="l"/>
            <a:r>
              <a:rPr lang="en-US" sz="24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te. </a:t>
            </a:r>
            <a:r>
              <a:rPr lang="en-US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ractive behavior occurs when one monkey swipes across the face of a conspecific, eliciting a reaction from the latter, followed by  deliberate actions by both animals.</a:t>
            </a:r>
            <a:endParaRPr lang="en-US" dirty="0"/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F8DA748F-2B64-440A-9920-DC237148EA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59105" y="1138081"/>
            <a:ext cx="6606540" cy="849417"/>
          </a:xfrm>
        </p:spPr>
        <p:txBody>
          <a:bodyPr>
            <a:noAutofit/>
          </a:bodyPr>
          <a:lstStyle/>
          <a:p>
            <a:pPr algn="l"/>
            <a:r>
              <a:rPr lang="en-US" sz="2400" b="1" dirty="0"/>
              <a:t>Supplemental Video 2</a:t>
            </a:r>
            <a:br>
              <a:rPr lang="en-US" sz="2400" dirty="0"/>
            </a:br>
            <a:br>
              <a:rPr lang="en-US" sz="2400" dirty="0"/>
            </a:br>
            <a:r>
              <a:rPr lang="en-US" sz="2400" dirty="0" err="1"/>
              <a:t>Colubus</a:t>
            </a:r>
            <a:r>
              <a:rPr lang="en-US" sz="2400" dirty="0"/>
              <a:t> monkeys displaying interactive and volitional behavior</a:t>
            </a:r>
          </a:p>
        </p:txBody>
      </p:sp>
      <p:pic>
        <p:nvPicPr>
          <p:cNvPr id="7" name="Monkeys">
            <a:hlinkClick r:id="" action="ppaction://media"/>
            <a:extLst>
              <a:ext uri="{FF2B5EF4-FFF2-40B4-BE49-F238E27FC236}">
                <a16:creationId xmlns:a16="http://schemas.microsoft.com/office/drawing/2014/main" id="{102F4BF3-9D06-41C9-8F89-5E75B30F3D5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847725" y="2495550"/>
            <a:ext cx="5829300" cy="49006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43420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998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0">
                <p:cTn id="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</TotalTime>
  <Words>43</Words>
  <Application>Microsoft Office PowerPoint</Application>
  <PresentationFormat>Custom</PresentationFormat>
  <Paragraphs>2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Video 2  Colubus monkeys displaying interactive and volitional behavior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Video 1  Spiny lobster displaying volitional behavior</dc:title>
  <dc:creator>Louis Irwin</dc:creator>
  <cp:lastModifiedBy>Irwin, Louis N</cp:lastModifiedBy>
  <cp:revision>3</cp:revision>
  <dcterms:created xsi:type="dcterms:W3CDTF">2022-03-09T18:32:13Z</dcterms:created>
  <dcterms:modified xsi:type="dcterms:W3CDTF">2024-02-03T19:26:15Z</dcterms:modified>
</cp:coreProperties>
</file>